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52" d="100"/>
          <a:sy n="52" d="100"/>
        </p:scale>
        <p:origin x="22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37786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48309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7081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288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2632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4428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03108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702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17353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0092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1870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0973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tângulo 6"/>
          <p:cNvSpPr/>
          <p:nvPr/>
        </p:nvSpPr>
        <p:spPr>
          <a:xfrm>
            <a:off x="0" y="5435288"/>
            <a:ext cx="6858000" cy="15204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156"/>
              </a:spcAft>
            </a:pPr>
            <a:r>
              <a:rPr lang="en-US" sz="1200" b="1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riation in the fruits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rphological parameters of plan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introgression lines of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nelli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o a genetic background of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copersic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8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wn at 400 µmol CO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otal fruit production p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ruit fresh weigh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 plant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uit diameter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ui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ngth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are presented as means ±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 =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)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t letters accompany means that differ between the genotypes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 by th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ukey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st. </a:t>
            </a:r>
            <a:endParaRPr lang="pt-B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tabLst>
                <a:tab pos="3002893" algn="l"/>
              </a:tabLst>
            </a:pPr>
            <a:endParaRPr lang="pt-B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7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t-BR"/>
          </a:p>
        </p:txBody>
      </p:sp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338517"/>
              </p:ext>
            </p:extLst>
          </p:nvPr>
        </p:nvGraphicFramePr>
        <p:xfrm>
          <a:off x="71258" y="590797"/>
          <a:ext cx="6691226" cy="46955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SPW 10.0 Graph" r:id="rId3" imgW="10627920" imgH="7458480" progId="SigmaPlotGraphicObject.9">
                  <p:embed/>
                </p:oleObj>
              </mc:Choice>
              <mc:Fallback>
                <p:oleObj name="SPW 10.0 Graph" r:id="rId3" imgW="10627920" imgH="745848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258" y="590797"/>
                        <a:ext cx="6691226" cy="46955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074796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88</TotalTime>
  <Words>93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o Office</vt:lpstr>
      <vt:lpstr>SPW 10.0 Graph</vt:lpstr>
      <vt:lpstr>Apresentação do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30</cp:revision>
  <dcterms:created xsi:type="dcterms:W3CDTF">2019-04-29T12:03:19Z</dcterms:created>
  <dcterms:modified xsi:type="dcterms:W3CDTF">2020-05-01T01:20:21Z</dcterms:modified>
</cp:coreProperties>
</file>